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18"/>
    <p:restoredTop sz="94681"/>
  </p:normalViewPr>
  <p:slideViewPr>
    <p:cSldViewPr snapToGrid="0">
      <p:cViewPr varScale="1">
        <p:scale>
          <a:sx n="62" d="100"/>
          <a:sy n="62" d="100"/>
        </p:scale>
        <p:origin x="216" y="1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324C-A1E1-71BB-7043-1E908E0FB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82B21A-9476-7CCA-4E12-CA31D43C53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0084A-686F-C1DB-CD18-889CA1C09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8FA9B-8272-4A5A-E8AF-10E700FB4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E75C0-F6B1-0A9B-A9F6-9980AF36B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13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E0D36-14DB-9318-2537-471F7E8A4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E42FF3-6A84-F96E-FE01-FBD1DF2BA0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D31D9-0D24-6FC0-6E3A-011A4D3C4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18FE9-DE08-1C63-3F80-8995DEDDA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BE43E-35EC-8537-7964-93B59BA8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457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3B013D-2C32-3B42-D58B-DF1BD8CED4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9E2CBD-9E6B-7164-8D26-03565666DC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1B9D80-6517-1D68-1107-902C2B87E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F44F8-5384-113A-0657-DF50ACBFC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B9987-0527-BB14-5ACC-1D6A2132E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76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CDF4B-AD3B-6AE5-612F-3B9965EC7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B8B329-DA79-BCB7-16DE-3A02BBA4D9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213388-B710-7413-CDFE-AC6685F85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055F88-5C33-39AC-95D7-3176F5D78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4A0AF-34A6-4C3D-51DC-8B0047A92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435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92C5C6-4415-F6B0-61FC-603D89778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001B40-7A3C-B55F-636A-753475FBB5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B98A34-AA02-61FD-7474-27378C9C9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4DF64D-1780-B3A5-7C31-08FF538E3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CB9560-7236-344B-4851-FF6FA968F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681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11AC2-551E-8194-5A5F-2D6ED674E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5856C6-04B8-CD2E-75A0-D7FA318828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1616D3-B671-D6F5-147A-A9DB1072F9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54AB1D-C03F-EF4B-7AC3-CF5122538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5276C7-BEAA-D4FA-766D-14D3E7F34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3772E7-BBC2-969A-CAA3-D48977E8F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5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F885D-BCA4-CEB6-1E09-01F8F9FDBC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A09195-220E-AF5C-59D2-B4F1C1FE78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A1BC25-DFD6-FE64-67FE-3F072478AE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974898-D284-C884-A635-621FF5B4F8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5223C3-41F6-D4B1-13B6-6F59A7AFC7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F4637B-1E1B-D888-1AB0-3AFA3EE0A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E9E103-9F5F-8C36-FFC2-B2F2A8425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E73327-3CAD-470B-2C5D-55004431A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427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4956CC-CCB9-0E46-639B-2674799EA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A1ABE4-2EF5-C735-1B3C-2271FE3F4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CC2099-470A-EAB3-0CED-5BB237BA3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1648D1-7739-AB36-E42C-3992B525F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90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CB60A6-36FF-90A8-0E2B-DD9DFC955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92F507-AC2C-A0B7-BC2E-B3A6AECC8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619752-DB5A-F855-E661-C7CA9A32B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491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5AAE4E-5086-81C3-82EC-0ECDD8A62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A3FFD-16EB-16CD-FC2D-843F649B3A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A2932E-C291-1CEA-E4B3-4CE70253A0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87398B-3623-E871-1711-F07C50C7C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4F0713-FA0E-5E4E-4328-5742F772A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F27DC3-7386-D7C0-52FA-D7920F027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92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C24BE-93F4-F342-37D1-916E032B9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C956A3-EB11-076F-46B5-41ACCDD2FA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DDF18C-646A-5F7C-96C0-F3B2F82B9E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FAF747-8570-778D-EC2E-19630C9E6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0CA277-7A83-EA8A-699D-AFF507BA0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F2F7F6-5ACA-ECA9-2706-90C37B123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447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69E720-896E-6075-971A-E468F0DC4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31C1E1-F2E2-D306-A969-CC2C35DA1D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91B4CF-0BE6-E938-C392-0EDEF20F75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68518-B39D-9B40-8786-C5F7B66AA366}" type="datetimeFigureOut">
              <a:rPr lang="en-US" smtClean="0"/>
              <a:t>10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3D5FB7-CCDD-7113-5346-28ACE80BBA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9FA08C-31E8-3917-89D3-DF87D0F114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F242E-5E7F-694D-B311-A6CDE32831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177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E76C70-0415-D6EE-7624-1D22ED74072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Methemoglobinemi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C39F4A-A259-EBC9-1A55-1F4B050297E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719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E36F2-C8FA-FAAF-C19E-90FD10FF8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CG</a:t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 descr="A picture containing timeline&#10;&#10;Description automatically generated">
            <a:extLst>
              <a:ext uri="{FF2B5EF4-FFF2-40B4-BE49-F238E27FC236}">
                <a16:creationId xmlns:a16="http://schemas.microsoft.com/office/drawing/2014/main" id="{4955D704-C932-37F3-6810-B3EE8A4F336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858886" y="1825625"/>
            <a:ext cx="6474227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1876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7A57B-328D-8345-E8EC-419250BCAA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itial Chest X-Ra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58B73A-220B-1D58-E9A5-DF04982B7F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EFEF342-D340-23DB-9B12-4BFC33265E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8218" y="1675289"/>
            <a:ext cx="5943600" cy="4652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60946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BA9D0-862A-9D96-14C7-B3298E4CC2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B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440F9E-7488-0953-95E6-50DE4772D3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hite Blood Cell: 6.07 * 10E9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Blood Cell Count: 5.75 * 10E12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moglobin: 16.6 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matocrit: 47.7 %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CV: 83.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CH: 28.9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g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CHC: 34.8 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DW: 12.6 %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latelet Count: 239 * 10E9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39775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A51B8-350C-18D8-61D4-1F227BB2E5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MP (plus phosphate/magnesiu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538E32-780B-126C-76E8-DB24A07584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>
            <a:normAutofit fontScale="92500" lnSpcReduction="20000"/>
          </a:bodyPr>
          <a:lstStyle/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odium: 141 mmol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tassium: 4.1 mmol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hloride: 106 mmol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2: 24 mmol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ion gap: 11 mmol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UN 11 m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reatinine: 0.63 m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lucose: 121 m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lcium: 9.0 m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otal Protein: 6.1 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lbumin: 51 U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ST: 28 U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LT: 10 U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FR: &gt;60 ml/min/1.73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q.m</a:t>
            </a:r>
            <a:endParaRPr lang="en-US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gnesium: 2.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hosphate: 3.5 m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32295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A214F3-04D0-DDE0-BB55-7F2CB79BB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opon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AE6486-55A2-37F6-3FDB-EDE437E86D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&lt;0.01 ng/mL</a:t>
            </a:r>
          </a:p>
        </p:txBody>
      </p:sp>
    </p:spTree>
    <p:extLst>
      <p:ext uri="{BB962C8B-B14F-4D97-AF65-F5344CB8AC3E}">
        <p14:creationId xmlns:p14="http://schemas.microsoft.com/office/powerpoint/2010/main" val="37717123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446F66-8C99-8489-CC62-9C163BAAD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B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71143F-856A-DA0C-82CC-88A046C846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H: 7.4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2: 47 mmHg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aO2: 104 mmHg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742950" marR="0" lvl="1" indent="-285750" fontAlgn="base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CO3: 2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q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31279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A53DF-DE2F-07F3-CA9E-D91D1CC7C4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ate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F97B76-F587-3117-37FA-483367CE65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3.4 mmol/L</a:t>
            </a:r>
          </a:p>
        </p:txBody>
      </p:sp>
    </p:spTree>
    <p:extLst>
      <p:ext uri="{BB962C8B-B14F-4D97-AF65-F5344CB8AC3E}">
        <p14:creationId xmlns:p14="http://schemas.microsoft.com/office/powerpoint/2010/main" val="13091278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95932-378F-26F7-A6EF-24BCC6AEF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MetHb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EF561F-9852-FC63-721C-10D62107CF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42%</a:t>
            </a:r>
          </a:p>
        </p:txBody>
      </p:sp>
    </p:spTree>
    <p:extLst>
      <p:ext uri="{BB962C8B-B14F-4D97-AF65-F5344CB8AC3E}">
        <p14:creationId xmlns:p14="http://schemas.microsoft.com/office/powerpoint/2010/main" val="3219625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05</Words>
  <Application>Microsoft Macintosh PowerPoint</Application>
  <PresentationFormat>Widescreen</PresentationFormat>
  <Paragraphs>4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Courier New</vt:lpstr>
      <vt:lpstr>Times New Roman</vt:lpstr>
      <vt:lpstr>Office Theme</vt:lpstr>
      <vt:lpstr>Methemoglobinemia</vt:lpstr>
      <vt:lpstr>ECG </vt:lpstr>
      <vt:lpstr>Initial Chest X-Ray</vt:lpstr>
      <vt:lpstr>CBC</vt:lpstr>
      <vt:lpstr>CMP (plus phosphate/magnesium)</vt:lpstr>
      <vt:lpstr>Troponin</vt:lpstr>
      <vt:lpstr>ABG</vt:lpstr>
      <vt:lpstr>Lactate </vt:lpstr>
      <vt:lpstr>MetHb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hemoglobinemia</dc:title>
  <dc:creator>Low, Cheyenne</dc:creator>
  <cp:lastModifiedBy>Low, Cheyenne</cp:lastModifiedBy>
  <cp:revision>6</cp:revision>
  <dcterms:created xsi:type="dcterms:W3CDTF">2022-10-12T21:39:59Z</dcterms:created>
  <dcterms:modified xsi:type="dcterms:W3CDTF">2022-10-12T21:54:33Z</dcterms:modified>
</cp:coreProperties>
</file>